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8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377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985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9200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07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8830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33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794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128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3702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800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380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A4DA9-9853-4135-88A0-C20E8D73534B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DEEB5-EF74-457F-B287-9CB6038528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386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247" y="2733908"/>
            <a:ext cx="2707910" cy="90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247" y="4615124"/>
            <a:ext cx="2707910" cy="9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630" y="3673213"/>
            <a:ext cx="2707910" cy="90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2935192" y="2524337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-GFP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3843121" y="2521131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4738987" y="2507242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1948096" y="3056380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730885" y="4865069"/>
            <a:ext cx="13933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mTOR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Ad-VT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580602" y="4001405"/>
            <a:ext cx="1543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752" y="2717585"/>
            <a:ext cx="2708350" cy="90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752" y="3661308"/>
            <a:ext cx="2708350" cy="9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752" y="4603219"/>
            <a:ext cx="2708350" cy="9000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7544901" y="2518701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RP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8452830" y="2515495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9348696" y="2501606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6542782" y="3013430"/>
            <a:ext cx="117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325571" y="4822119"/>
            <a:ext cx="13933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mTOR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Ad-VT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175288" y="3958455"/>
            <a:ext cx="1543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244742" y="2379478"/>
            <a:ext cx="838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3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6001948" y="2481417"/>
            <a:ext cx="838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3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652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宽屏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905381255@qq.com</dc:creator>
  <cp:lastModifiedBy>905381255@qq.com</cp:lastModifiedBy>
  <cp:revision>1</cp:revision>
  <dcterms:created xsi:type="dcterms:W3CDTF">2021-08-25T13:45:00Z</dcterms:created>
  <dcterms:modified xsi:type="dcterms:W3CDTF">2021-08-25T13:45:12Z</dcterms:modified>
</cp:coreProperties>
</file>